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7102475" cy="93884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B38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88" d="100"/>
          <a:sy n="88" d="100"/>
        </p:scale>
        <p:origin x="66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56D1BB-FF46-47D6-BF9B-BD05FDF842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A02215-39DF-44D3-B860-FD4B693820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382EB5-A3DB-442A-8A9E-AF719E5D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F51F49-8F9A-47DA-8E72-17B51ECA3E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4A4E06-D4DB-42D6-8D78-05CEE9213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77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2F470-FD33-4BFF-8293-926FBD9C7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243CF5-4CE3-477C-85B8-ED3AA94834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3A9B4-B93F-4277-95E3-6D800B694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51C1E0-891C-4A1C-AD50-526F0C6B8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1C4D0F-5CC8-4C43-8DFC-34623DDBE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272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CEBD55-0CB0-4D7B-9DFB-1A775F0C0EF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BDD5D9-63CE-4193-8C32-C2D775E32F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768FCC-C96B-47B9-BBBF-18FAF648D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4F804C-5A02-440C-B607-7F201935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6A1E7F-9C30-442A-9C53-333328AD1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37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1A7F1A-ABED-4AB0-9EAB-50BCDCA60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4E26BF-D973-4A9B-860A-319E222660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09ACAD-1E4E-4786-8BF4-3DB946A97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93DBCF-6B8F-4DDE-8EFD-45E0B955A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2F6EBC-A674-4437-B44B-816C3CB99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144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452EC-73BF-4954-A336-5B6E76D02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4ED36F-8D19-4A1C-B8F4-1D8A170B04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07A8DA-D2F3-4DF9-85B4-C325F6483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CEF1C7-4EA6-457E-B675-8F0B8E10E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535348-F8A4-4DEC-9C77-4CA4A9CC9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106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50405-1E6A-44D5-9F55-B15796E4DA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3D96E-E35C-4F33-9D4B-072EDB0ABB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3D7213-FCDD-4519-91EB-9BC5429C3A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A26069-D3EF-42A0-BDA0-CA90CBD06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D3E61A-1029-410C-990A-8F803D79D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679EEF-125C-4298-915F-A60D60B42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596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68DD7-0E7A-4A11-9CBC-F644B77EA2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E3A277-6896-4D2C-8506-1BA9E7393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A02ECA-F653-41DE-8DC8-44BDEE2183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E9F117-1061-4747-8F34-EC86CFD63C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EF119C-1575-4871-89B8-CB3C0C444F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44B8E8B-A228-467A-887B-083DBA845D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A3204F-186A-4BB6-B38A-A305B7CA7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290303-13A4-4C31-A524-D3576DB6F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0112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35B58-EEF7-4CCC-BD12-52EFD5486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E87EA-5F2F-4FC2-8F34-E81F134CD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746099-76EF-4488-835D-F97105C602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D840E6-93A9-4221-BD1F-95E76D482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911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E7897E-777F-4029-ABC0-15AC7B222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4839BB-3015-494B-87E9-3B884F98F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BAC4A5-B1B0-4BFB-AB19-5F75FEDA6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5959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68EF1-7304-4832-BE13-D6D1E6263F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4AE976-F1B5-456F-988A-F7A495B13F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2A9068-C470-4EF5-8C85-96F2FC83FB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2F63B6-94A1-474A-8968-9E35BF5E1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9A4307-1318-4570-836D-24020A40F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ADD920-3BDA-4BAA-AA05-A733E756E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58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348363-F62C-43CE-A869-EB35F4B1F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F97CA5-534E-444B-922E-1C1709940A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0188BE-0C55-4875-8A81-793D908473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09B25F-B387-44C9-B60A-A0A576778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671725-BEFA-4ACD-B702-F750F02AD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BFBE16-498A-4D36-B1EC-6B6631ADE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73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3235F4-271B-4F58-8087-F4740ED26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6DD009-584F-4F1C-9084-AAEB1AB636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5B5B1E-8780-4805-8B18-788487818A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B839AF-00F6-4D5C-A4AE-8B7E50D788F0}" type="datetimeFigureOut">
              <a:rPr lang="en-US" smtClean="0"/>
              <a:t>2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2C4F6E-1E11-4E2B-88A8-E613E0D6CD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3DFFB2-2F7D-487A-9FC0-EB03943860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77C49-D17A-4C9E-A382-9D0AF3A2F1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842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18">
            <a:extLst>
              <a:ext uri="{FF2B5EF4-FFF2-40B4-BE49-F238E27FC236}">
                <a16:creationId xmlns:a16="http://schemas.microsoft.com/office/drawing/2014/main" id="{4A26C853-1B3B-456E-AC56-9D817CF6BF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7588" y="158019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0A8D3216-C1F8-45F5-AE8F-3E7DA6BCEC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2841890"/>
              </p:ext>
            </p:extLst>
          </p:nvPr>
        </p:nvGraphicFramePr>
        <p:xfrm>
          <a:off x="2268082" y="2037397"/>
          <a:ext cx="6323806" cy="3020063"/>
        </p:xfrm>
        <a:graphic>
          <a:graphicData uri="http://schemas.openxmlformats.org/drawingml/2006/table">
            <a:tbl>
              <a:tblPr/>
              <a:tblGrid>
                <a:gridCol w="1789429">
                  <a:extLst>
                    <a:ext uri="{9D8B030D-6E8A-4147-A177-3AD203B41FA5}">
                      <a16:colId xmlns:a16="http://schemas.microsoft.com/office/drawing/2014/main" val="1804186609"/>
                    </a:ext>
                  </a:extLst>
                </a:gridCol>
                <a:gridCol w="1511459">
                  <a:extLst>
                    <a:ext uri="{9D8B030D-6E8A-4147-A177-3AD203B41FA5}">
                      <a16:colId xmlns:a16="http://schemas.microsoft.com/office/drawing/2014/main" val="73946750"/>
                    </a:ext>
                  </a:extLst>
                </a:gridCol>
                <a:gridCol w="1511459">
                  <a:extLst>
                    <a:ext uri="{9D8B030D-6E8A-4147-A177-3AD203B41FA5}">
                      <a16:colId xmlns:a16="http://schemas.microsoft.com/office/drawing/2014/main" val="249114972"/>
                    </a:ext>
                  </a:extLst>
                </a:gridCol>
                <a:gridCol w="1511459">
                  <a:extLst>
                    <a:ext uri="{9D8B030D-6E8A-4147-A177-3AD203B41FA5}">
                      <a16:colId xmlns:a16="http://schemas.microsoft.com/office/drawing/2014/main" val="841330649"/>
                    </a:ext>
                  </a:extLst>
                </a:gridCol>
              </a:tblGrid>
              <a:tr h="68561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ty, n (%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bined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i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10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PAFB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i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JBC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 i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=5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874866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atrol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2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 (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4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5804015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dministrative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 (4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4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4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9026570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te Guard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1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2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 (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1649172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ehicle Maintenance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2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4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 (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4071105"/>
                  </a:ext>
                </a:extLst>
              </a:tr>
              <a:tr h="38907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-9 handler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1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 (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6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2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5980088"/>
                  </a:ext>
                </a:extLst>
              </a:tr>
              <a:tr h="389075">
                <a:tc gridSpan="4">
                  <a:txBody>
                    <a:bodyPr/>
                    <a:lstStyle/>
                    <a:p>
                      <a:endParaRPr lang="en-US" sz="14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540" marR="2540" marT="254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18475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9363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84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 McNeilly</dc:creator>
  <cp:lastModifiedBy>Jennifer Kerr</cp:lastModifiedBy>
  <cp:revision>9</cp:revision>
  <cp:lastPrinted>2021-02-23T14:58:17Z</cp:lastPrinted>
  <dcterms:created xsi:type="dcterms:W3CDTF">2021-01-12T16:58:12Z</dcterms:created>
  <dcterms:modified xsi:type="dcterms:W3CDTF">2021-02-23T14:59:43Z</dcterms:modified>
</cp:coreProperties>
</file>